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5">
  <p:sldMasterIdLst>
    <p:sldMasterId id="2147483648" r:id="rId1"/>
  </p:sldMasterIdLst>
  <p:notesMasterIdLst>
    <p:notesMasterId r:id="rId3"/>
  </p:notesMasterIdLst>
  <p:sldIdLst>
    <p:sldId id="354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118CDF"/>
    <a:srgbClr val="16A8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1749" autoAdjust="0"/>
    <p:restoredTop sz="88454" autoAdjust="0"/>
  </p:normalViewPr>
  <p:slideViewPr>
    <p:cSldViewPr>
      <p:cViewPr varScale="1">
        <p:scale>
          <a:sx n="85" d="100"/>
          <a:sy n="85" d="100"/>
        </p:scale>
        <p:origin x="2886" y="144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52FAFD0-EF8C-554B-B034-4442DE591FA0}" type="datetimeFigureOut">
              <a:rPr lang="en-US" smtClean="0"/>
              <a:t>2/12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CB1FB10-D472-764B-87F9-C134BDEA3E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818395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CB1FB10-D472-764B-87F9-C134BDEA3E12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341682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81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8143370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184083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98"/>
            <a:ext cx="1543050" cy="7802033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98"/>
            <a:ext cx="4514850" cy="780203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24877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381225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31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809491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14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14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479355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253696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913728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644652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1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97" y="364081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10" y="1913481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013967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581409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14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48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48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48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443347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92227899"/>
              </p:ext>
            </p:extLst>
          </p:nvPr>
        </p:nvGraphicFramePr>
        <p:xfrm>
          <a:off x="228600" y="762000"/>
          <a:ext cx="6172196" cy="960296"/>
        </p:xfrm>
        <a:graphic>
          <a:graphicData uri="http://schemas.openxmlformats.org/drawingml/2006/table">
            <a:tbl>
              <a:tblPr>
                <a:tableStyleId>{616DA210-FB5B-4158-B5E0-FEB733F419BA}</a:tableStyleId>
              </a:tblPr>
              <a:tblGrid>
                <a:gridCol w="1358431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43761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437615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437615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437615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437615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437615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437615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437615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  <a:gridCol w="437615">
                  <a:extLst>
                    <a:ext uri="{9D8B030D-6E8A-4147-A177-3AD203B41FA5}">
                      <a16:colId xmlns:a16="http://schemas.microsoft.com/office/drawing/2014/main" val="20009"/>
                    </a:ext>
                  </a:extLst>
                </a:gridCol>
                <a:gridCol w="437615">
                  <a:extLst>
                    <a:ext uri="{9D8B030D-6E8A-4147-A177-3AD203B41FA5}">
                      <a16:colId xmlns:a16="http://schemas.microsoft.com/office/drawing/2014/main" val="20010"/>
                    </a:ext>
                  </a:extLst>
                </a:gridCol>
                <a:gridCol w="437615">
                  <a:extLst>
                    <a:ext uri="{9D8B030D-6E8A-4147-A177-3AD203B41FA5}">
                      <a16:colId xmlns:a16="http://schemas.microsoft.com/office/drawing/2014/main" val="20011"/>
                    </a:ext>
                  </a:extLst>
                </a:gridCol>
              </a:tblGrid>
              <a:tr h="164106"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mpound ID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38" marR="6838" marT="6838" marB="0" anchor="ctr"/>
                </a:tc>
                <a:tc gridSpan="8"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pp (10</a:t>
                      </a:r>
                      <a:r>
                        <a:rPr lang="en-US" sz="1000" b="1" u="none" strike="noStrike" baseline="30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6</a:t>
                      </a:r>
                      <a:r>
                        <a:rPr lang="en-US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cm/s) mean and SD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38" marR="6838" marT="6838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fflux ratio (ER)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38" marR="6838" marT="6838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3675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T MDCKII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38" marR="6838" marT="6838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DR1-MDCKII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38" marR="6838" marT="6838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T MDCKII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38" marR="6838" marT="6838" marB="0" anchor="ctr"/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DR1-MDCKII 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38" marR="6838" marT="6838" marB="0" anchor="ctr"/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DR1/ WT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38" marR="6838" marT="6838" marB="0" anchor="ctr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3675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-B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38" marR="6838" marT="6838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-A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38" marR="6838" marT="6838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-B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38" marR="6838" marT="6838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-A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38" marR="6838" marT="6838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3675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an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38" marR="6838" marT="68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D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38" marR="6838" marT="68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an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38" marR="6838" marT="68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D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38" marR="6838" marT="68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an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38" marR="6838" marT="68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D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38" marR="6838" marT="68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an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38" marR="6838" marT="68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D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38" marR="6838" marT="6838" marB="0" anchor="b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36755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458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38" marR="6838" marT="68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1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38" marR="6838" marT="68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7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38" marR="6838" marT="68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.7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38" marR="6838" marT="68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5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38" marR="6838" marT="68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9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38" marR="6838" marT="68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38" marR="6838" marT="68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.3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38" marR="6838" marT="68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1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38" marR="6838" marT="68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5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38" marR="6838" marT="68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9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38" marR="6838" marT="68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38" marR="6838" marT="6838" marB="0" anchor="b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43593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igoxin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38" marR="6838" marT="68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38" marR="6838" marT="68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38" marR="6838" marT="68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38" marR="6838" marT="68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38" marR="6838" marT="68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38" marR="6838" marT="68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38" marR="6838" marT="68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.4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38" marR="6838" marT="68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5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38" marR="6838" marT="68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0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38" marR="6838" marT="68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4.2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38" marR="6838" marT="683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5.4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38" marR="6838" marT="6838" marB="0" anchor="b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</a:tbl>
          </a:graphicData>
        </a:graphic>
      </p:graphicFrame>
      <p:sp>
        <p:nvSpPr>
          <p:cNvPr id="3" name="Rectangle 2"/>
          <p:cNvSpPr/>
          <p:nvPr/>
        </p:nvSpPr>
        <p:spPr>
          <a:xfrm>
            <a:off x="180113" y="228600"/>
            <a:ext cx="6172200" cy="4308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Table 2. Permeability assessment for compound C458 in MDR1 (P-gp) 		transfected MDCKII cells</a:t>
            </a:r>
            <a:endParaRPr lang="en-US" sz="1100" b="1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722089AB-77B8-0F11-24ED-064EFBFF2660}"/>
              </a:ext>
            </a:extLst>
          </p:cNvPr>
          <p:cNvSpPr txBox="1"/>
          <p:nvPr/>
        </p:nvSpPr>
        <p:spPr>
          <a:xfrm>
            <a:off x="220985" y="1734321"/>
            <a:ext cx="6210744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app (B-A) indicates the apparent permeability coefficient in basolateral to apical direction, and Papp (A-B) indicates the apparent permeability coefficient in apical to basolateral direction in wild-type MDCKII and MDR1-MDCKII cells. Efflux ratio can be determined using the following equation: Efflux Ratio =Papp(B-A) / Papp(A-B) </a:t>
            </a:r>
          </a:p>
        </p:txBody>
      </p:sp>
    </p:spTree>
    <p:extLst>
      <p:ext uri="{BB962C8B-B14F-4D97-AF65-F5344CB8AC3E}">
        <p14:creationId xmlns:p14="http://schemas.microsoft.com/office/powerpoint/2010/main" val="73582367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Metadata/LabelInfo.xml><?xml version="1.0" encoding="utf-8"?>
<clbl:labelList xmlns:clbl="http://schemas.microsoft.com/office/2020/mipLabelMetadata">
  <clbl:label id="{11372f5f-8e19-4efb-8afe-8eac20a980c4}" enabled="1" method="Standard" siteId="{a25fff9c-3f63-4fb2-9a8a-d9bdd0321f9a}" contentBits="0" removed="0"/>
</clbl:labelList>
</file>

<file path=docProps/app.xml><?xml version="1.0" encoding="utf-8"?>
<Properties xmlns="http://schemas.openxmlformats.org/officeDocument/2006/extended-properties" xmlns:vt="http://schemas.openxmlformats.org/officeDocument/2006/docPropsVTypes">
  <TotalTime>150712</TotalTime>
  <Words>141</Words>
  <Application>Microsoft Office PowerPoint</Application>
  <PresentationFormat>On-screen Show (4:3)</PresentationFormat>
  <Paragraphs>47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Mayo Clini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ergey A Trushin</dc:creator>
  <cp:lastModifiedBy>Trushin, Sergey A., Ph.D.</cp:lastModifiedBy>
  <cp:revision>604</cp:revision>
  <cp:lastPrinted>2022-11-09T15:46:24Z</cp:lastPrinted>
  <dcterms:created xsi:type="dcterms:W3CDTF">2020-01-31T17:27:01Z</dcterms:created>
  <dcterms:modified xsi:type="dcterms:W3CDTF">2025-02-12T20:37:52Z</dcterms:modified>
</cp:coreProperties>
</file>